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3.xml.rels" ContentType="application/vnd.openxmlformats-package.relationships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notesSlide9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09B2BF-5BBC-4378-974F-C5614909917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5902A2-0F4D-4A62-8EC9-EA8296BFE02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7FC244-D7F3-46A3-B48A-458628E35F7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lank slide (60 min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1C692E-3586-4A7F-86FF-A07B383F382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lank slide (60 min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BBB31D-C0CC-4137-BDEA-2F247FD0A05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lank slide (60 min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5341A2-9728-4DA5-93FE-B6E55D5C202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0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lank slide (60 min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0361F1-89E0-4245-BD55-7445DB399BA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lank slide (60 min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2411AE-B324-47C4-89BA-6EAB16E744A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5F5050-2B89-499B-9CB8-DBE7E943267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8074F3-FCD2-4A00-938A-4480CBD481F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8BE609-C4AB-4110-9B62-5B53FC1429C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580F3C-BE9D-4FE0-B767-621C861956E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574EFD-DABE-491C-A75C-0B99D7CC44B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10E21A-9949-4350-860A-8049B422A2F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8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2733E0-7B6B-45BE-B972-A27C47C2473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9185A-7EF4-440C-B213-C9E84C1DEF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DD4A6-1F3F-464C-A4B5-6E45E73514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98E20-E0A1-4706-B6F6-F2A0F51ED7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B6D49-DADE-477C-94C8-5AD4C0AD20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DB1A9-783F-4FE6-9342-0FF3311975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399C2-A5C2-4BB8-90C9-71891CD932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10D97-0A4F-4E2A-AB52-F3731C2883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31370-E4BF-4309-9F09-A0ED5E72D7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E691E-26A2-4580-A688-FCC1288410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E7341-CC46-4A91-843E-A3B3FEF5ED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4936A-A0C4-4CD5-9840-B25CFB440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480A8-D296-4882-89BD-463E3B1393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d2d2d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3024E0-7D7C-4582-AE8D-2A7F3ED8DD4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traight Connector 2"/>
          <p:cNvSpPr/>
          <p:nvPr/>
        </p:nvSpPr>
        <p:spPr>
          <a:xfrm>
            <a:off x="2449440" y="3429000"/>
            <a:ext cx="7315200" cy="0"/>
          </a:xfrm>
          <a:prstGeom prst="line">
            <a:avLst/>
          </a:prstGeom>
          <a:ln w="507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17"/>
          <p:cNvSpPr/>
          <p:nvPr/>
        </p:nvSpPr>
        <p:spPr>
          <a:xfrm>
            <a:off x="6095880" y="500040"/>
            <a:ext cx="0" cy="5486400"/>
          </a:xfrm>
          <a:prstGeom prst="line">
            <a:avLst/>
          </a:prstGeom>
          <a:ln w="50760">
            <a:solidFill>
              <a:srgbClr val="4472c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"/>
          <p:cNvSpPr/>
          <p:nvPr/>
        </p:nvSpPr>
        <p:spPr>
          <a:xfrm>
            <a:off x="291960" y="130320"/>
            <a:ext cx="792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lignment slide;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check projector focus,  press ↓ to start presentation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-61920" y="474840"/>
            <a:ext cx="12439800" cy="640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49" dur="indefinite" restart="never" nodeType="tmRoot">
          <p:childTnLst>
            <p:seq>
              <p:cTn id="50" dur="indefinite" nodeType="mainSeq">
                <p:childTnLst>
                  <p:par>
                    <p:cTn id="51" nodeType="clickEffect" fill="hold">
                      <p:stCondLst>
                        <p:cond delay="0"/>
                      </p:stCondLst>
                      <p:childTnLst>
                        <p:par>
                          <p:cTn id="52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3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2.96296E-006 L 1.875E-006 -0.03982 E">
                                      <p:cBhvr>
                                        <p:cTn id="54" dur="500" fill="hold"/>
                                        <p:tgtEl>
                                          <p:spTgt spid="60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Audacity Sine 400Hz 1amp 0dB 100ms Int20sec" descr=""/>
          <p:cNvPicPr/>
          <p:nvPr/>
        </p:nvPicPr>
        <p:blipFill>
          <a:blip r:embed="rId1"/>
          <a:stretch/>
        </p:blipFill>
        <p:spPr>
          <a:xfrm>
            <a:off x="5791320" y="3124080"/>
            <a:ext cx="609480" cy="609840"/>
          </a:xfrm>
          <a:prstGeom prst="rect">
            <a:avLst/>
          </a:prstGeom>
          <a:ln w="0">
            <a:noFill/>
          </a:ln>
        </p:spPr>
      </p:pic>
    </p:spTree>
  </p:cSld>
  <p:timing>
    <p:tnLst>
      <p:par>
        <p:cTn id="55" dur="indefinite" restart="never" nodeType="tmRoot">
          <p:childTnLst>
            <p:seq>
              <p:cTn id="56" dur="indefinite" nodeType="mainSeq">
                <p:childTnLst>
                  <p:par>
                    <p:cTn id="57" nodeType="clickEffect" fill="hold">
                      <p:stCondLst>
                        <p:cond delay="0"/>
                      </p:stCondLst>
                      <p:childTnLst>
                        <p:par>
                          <p:cTn id="5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9" nodeType="with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0" dur="20000" fill="hold"/>
                                        <p:tgtEl>
                                          <p:spTgt spid="6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Audacity Sine 400Hz 100 ms 20x 1secInt" descr=""/>
          <p:cNvPicPr/>
          <p:nvPr/>
        </p:nvPicPr>
        <p:blipFill>
          <a:blip r:embed="rId1"/>
          <a:stretch/>
        </p:blipFill>
        <p:spPr>
          <a:xfrm>
            <a:off x="5851440" y="3184560"/>
            <a:ext cx="487440" cy="487440"/>
          </a:xfrm>
          <a:prstGeom prst="rect">
            <a:avLst/>
          </a:prstGeom>
          <a:ln w="0">
            <a:noFill/>
          </a:ln>
        </p:spPr>
      </p:pic>
    </p:spTree>
  </p:cSld>
  <p:timing>
    <p:tnLst>
      <p:par>
        <p:cTn id="61" dur="indefinite" restart="never" nodeType="tmRoot">
          <p:childTnLst>
            <p:seq>
              <p:cTn id="62" dur="indefinite" nodeType="mainSeq">
                <p:childTnLst>
                  <p:par>
                    <p:cTn id="63" nodeType="clickEffect" fill="hold">
                      <p:stCondLst>
                        <p:cond delay="0"/>
                      </p:stCondLst>
                      <p:childTnLst>
                        <p:par>
                          <p:cTn id="6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65" nodeType="with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6" dur="20000" fill="hold"/>
                                        <p:tgtEl>
                                          <p:spTgt spid="6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Audacity Sine 400Hz 1amp 0dB 100ms Int20sec" descr=""/>
          <p:cNvPicPr/>
          <p:nvPr/>
        </p:nvPicPr>
        <p:blipFill>
          <a:blip r:embed="rId1"/>
          <a:stretch/>
        </p:blipFill>
        <p:spPr>
          <a:xfrm>
            <a:off x="5791320" y="3124080"/>
            <a:ext cx="609480" cy="609840"/>
          </a:xfrm>
          <a:prstGeom prst="rect">
            <a:avLst/>
          </a:prstGeom>
          <a:ln w="0">
            <a:noFill/>
          </a:ln>
        </p:spPr>
      </p:pic>
    </p:spTree>
  </p:cSld>
  <p:timing>
    <p:tnLst>
      <p:par>
        <p:cTn id="67" dur="indefinite" restart="never" nodeType="tmRoot">
          <p:childTnLst>
            <p:seq>
              <p:cTn id="68" dur="indefinite" nodeType="mainSeq">
                <p:childTnLst>
                  <p:par>
                    <p:cTn id="69" nodeType="clickEffect" fill="hold">
                      <p:stCondLst>
                        <p:cond delay="0"/>
                      </p:stCondLst>
                      <p:childTnLst>
                        <p:par>
                          <p:cTn id="7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71" nodeType="with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72" dur="20000" fill="hold"/>
                                        <p:tgtEl>
                                          <p:spTgt spid="6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"/>
          <p:cNvSpPr/>
          <p:nvPr/>
        </p:nvSpPr>
        <p:spPr>
          <a:xfrm>
            <a:off x="82440" y="163440"/>
            <a:ext cx="273240" cy="55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5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7" dur="indefinite" restart="never" nodeType="tmRoot">
          <p:childTnLst>
            <p:seq>
              <p:cTn id="8" dur="indefinite" nodeType="mainSeq">
                <p:childTnLst>
                  <p:par>
                    <p:cTn id="9" nodeType="clickEffect" fill="hold">
                      <p:stCondLst>
                        <p:cond delay="0"/>
                      </p:stCondLst>
                      <p:childTnLst>
                        <p:par>
                          <p:cTn id="1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-0.08102 L 1.875E-006 -0.04098 E">
                                      <p:cBhvr>
                                        <p:cTn id="12" dur="8000" fill="hold"/>
                                        <p:tgtEl>
                                          <p:spTgt spid="53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3" dur="indefinite" restart="never" nodeType="tmRoot">
          <p:childTnLst>
            <p:seq>
              <p:cTn id="14" dur="indefinite" nodeType="mainSeq">
                <p:childTnLst>
                  <p:par>
                    <p:cTn id="15" nodeType="clickEffect" fill="hold">
                      <p:stCondLst>
                        <p:cond delay="0"/>
                      </p:stCondLst>
                      <p:childTnLst>
                        <p:par>
                          <p:cTn id="1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2.96296E-006 L 1.875E-006 -0.03982 E">
                                      <p:cBhvr>
                                        <p:cTn id="18" dur="8000" fill="hold"/>
                                        <p:tgtEl>
                                          <p:spTgt spid="5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9" dur="indefinite" restart="never" nodeType="tmRoot">
          <p:childTnLst>
            <p:seq>
              <p:cTn id="20" dur="indefinite" nodeType="mainSeq">
                <p:childTnLst>
                  <p:par>
                    <p:cTn id="21" nodeType="clickEffect" fill="hold">
                      <p:stCondLst>
                        <p:cond delay="0"/>
                      </p:stCondLst>
                      <p:childTnLst>
                        <p:par>
                          <p:cTn id="22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3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-0.08102 L 1.875E-006 -0.04098 E">
                                      <p:cBhvr>
                                        <p:cTn id="24" dur="8000" fill="hold"/>
                                        <p:tgtEl>
                                          <p:spTgt spid="55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b4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25" dur="indefinite" restart="never" nodeType="tmRoot">
          <p:childTnLst>
            <p:seq>
              <p:cTn id="26" dur="indefinite" nodeType="mainSeq">
                <p:childTnLst>
                  <p:par>
                    <p:cTn id="27" nodeType="clickEffect" fill="hold">
                      <p:stCondLst>
                        <p:cond delay="0"/>
                      </p:stCondLst>
                      <p:childTnLst>
                        <p:par>
                          <p:cTn id="2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9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2.96296E-006 L 1.875E-006 -0.03982 E">
                                      <p:cBhvr>
                                        <p:cTn id="30" dur="8000" fill="hold"/>
                                        <p:tgtEl>
                                          <p:spTgt spid="5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31" dur="indefinite" restart="never" nodeType="tmRoot">
          <p:childTnLst>
            <p:seq>
              <p:cTn id="32" dur="indefinite" nodeType="mainSeq">
                <p:childTnLst>
                  <p:par>
                    <p:cTn id="33" nodeType="clickEffect" fill="hold">
                      <p:stCondLst>
                        <p:cond delay="0"/>
                      </p:stCondLst>
                      <p:childTnLst>
                        <p:par>
                          <p:cTn id="3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35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-0.08102 L 1.875E-006 -0.04098 E">
                                      <p:cBhvr>
                                        <p:cTn id="36" dur="8000" fill="hold"/>
                                        <p:tgtEl>
                                          <p:spTgt spid="5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e6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37" dur="indefinite" restart="never" nodeType="tmRoot">
          <p:childTnLst>
            <p:seq>
              <p:cTn id="38" dur="indefinite" nodeType="mainSeq">
                <p:childTnLst>
                  <p:par>
                    <p:cTn id="39" nodeType="clickEffect" fill="hold">
                      <p:stCondLst>
                        <p:cond delay="0"/>
                      </p:stCondLst>
                      <p:childTnLst>
                        <p:par>
                          <p:cTn id="4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41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2.96296E-006 L 1.875E-006 -0.03982 E">
                                      <p:cBhvr>
                                        <p:cTn id="42" dur="8000" fill="hold"/>
                                        <p:tgtEl>
                                          <p:spTgt spid="5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6"/>
          <p:cNvSpPr/>
          <p:nvPr/>
        </p:nvSpPr>
        <p:spPr>
          <a:xfrm>
            <a:off x="-61920" y="-603360"/>
            <a:ext cx="12439800" cy="80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▬▬▬▬▬▬▬▬▬▬▬▬▬▬▬▬▬▬▬▬▬▬▬▬▬▬▬▬▬▬▬▬▬▬▬▬▬▬▬▬▬▬▬▬▬▬▬▬▬▬▬▬▬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43" dur="indefinite" restart="never" nodeType="tmRoot">
          <p:childTnLst>
            <p:seq>
              <p:cTn id="44" dur="indefinite" nodeType="mainSeq">
                <p:childTnLst>
                  <p:par>
                    <p:cTn id="45" nodeType="clickEffect" fill="hold">
                      <p:stCondLst>
                        <p:cond delay="0"/>
                      </p:stCondLst>
                      <p:childTnLst>
                        <p:par>
                          <p:cTn id="4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47" nodeType="withEffect" fill="hold" presetClass="path" presetID="42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006 -0.08102 L 1.875E-006 -0.04098 E">
                                      <p:cBhvr>
                                        <p:cTn id="48" dur="500" fill="hold"/>
                                        <p:tgtEl>
                                          <p:spTgt spid="5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6-06T19:00:59Z</dcterms:created>
  <dc:creator>Bestoso, Danielle</dc:creator>
  <dc:description/>
  <dc:language>en-US</dc:language>
  <cp:lastModifiedBy>Creton, Robbert</cp:lastModifiedBy>
  <dcterms:modified xsi:type="dcterms:W3CDTF">2019-07-06T04:08:52Z</dcterms:modified>
  <cp:revision>66</cp:revision>
  <dc:subject/>
  <dc:title>PowerPoint Presentation</dc:title>
</cp:coreProperties>
</file>